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9" autoAdjust="0"/>
    <p:restoredTop sz="94660"/>
  </p:normalViewPr>
  <p:slideViewPr>
    <p:cSldViewPr snapToGrid="0">
      <p:cViewPr>
        <p:scale>
          <a:sx n="212" d="100"/>
          <a:sy n="212" d="100"/>
        </p:scale>
        <p:origin x="-3568" y="-7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microsoft.com/office/2016/11/relationships/changesInfo" Target="changesInfos/changesInfo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hielmetti, G, Dr [gghielmetti@sun.ac.za]" userId="75ca0a8f-d75b-460c-b510-c107276c4769" providerId="ADAL" clId="{492E668B-7552-47E9-964C-A1C6E5B17D9B}"/>
    <pc:docChg chg="undo redo custSel modSld">
      <pc:chgData name="Ghielmetti, G, Dr [gghielmetti@sun.ac.za]" userId="75ca0a8f-d75b-460c-b510-c107276c4769" providerId="ADAL" clId="{492E668B-7552-47E9-964C-A1C6E5B17D9B}" dt="2023-07-17T11:27:22.927" v="184" actId="20577"/>
      <pc:docMkLst>
        <pc:docMk/>
      </pc:docMkLst>
      <pc:sldChg chg="modSp mod">
        <pc:chgData name="Ghielmetti, G, Dr [gghielmetti@sun.ac.za]" userId="75ca0a8f-d75b-460c-b510-c107276c4769" providerId="ADAL" clId="{492E668B-7552-47E9-964C-A1C6E5B17D9B}" dt="2023-07-17T10:39:52.726" v="9" actId="20577"/>
        <pc:sldMkLst>
          <pc:docMk/>
          <pc:sldMk cId="3031652824" sldId="256"/>
        </pc:sldMkLst>
        <pc:spChg chg="mod">
          <ac:chgData name="Ghielmetti, G, Dr [gghielmetti@sun.ac.za]" userId="75ca0a8f-d75b-460c-b510-c107276c4769" providerId="ADAL" clId="{492E668B-7552-47E9-964C-A1C6E5B17D9B}" dt="2023-07-17T10:39:52.726" v="9" actId="20577"/>
          <ac:spMkLst>
            <pc:docMk/>
            <pc:sldMk cId="3031652824" sldId="256"/>
            <ac:spMk id="9" creationId="{6FA70752-86C8-4103-232E-267BB3B079F1}"/>
          </ac:spMkLst>
        </pc:spChg>
      </pc:sldChg>
      <pc:sldChg chg="modSp mod">
        <pc:chgData name="Ghielmetti, G, Dr [gghielmetti@sun.ac.za]" userId="75ca0a8f-d75b-460c-b510-c107276c4769" providerId="ADAL" clId="{492E668B-7552-47E9-964C-A1C6E5B17D9B}" dt="2023-07-17T10:40:04.170" v="10"/>
        <pc:sldMkLst>
          <pc:docMk/>
          <pc:sldMk cId="2201153328" sldId="257"/>
        </pc:sldMkLst>
        <pc:spChg chg="mod">
          <ac:chgData name="Ghielmetti, G, Dr [gghielmetti@sun.ac.za]" userId="75ca0a8f-d75b-460c-b510-c107276c4769" providerId="ADAL" clId="{492E668B-7552-47E9-964C-A1C6E5B17D9B}" dt="2023-07-17T10:40:04.170" v="10"/>
          <ac:spMkLst>
            <pc:docMk/>
            <pc:sldMk cId="2201153328" sldId="257"/>
            <ac:spMk id="6" creationId="{55D8137E-B376-7F42-E8D7-5257D9610BE8}"/>
          </ac:spMkLst>
        </pc:spChg>
      </pc:sldChg>
      <pc:sldChg chg="modSp mod">
        <pc:chgData name="Ghielmetti, G, Dr [gghielmetti@sun.ac.za]" userId="75ca0a8f-d75b-460c-b510-c107276c4769" providerId="ADAL" clId="{492E668B-7552-47E9-964C-A1C6E5B17D9B}" dt="2023-07-17T10:40:09.615" v="11"/>
        <pc:sldMkLst>
          <pc:docMk/>
          <pc:sldMk cId="822229440" sldId="258"/>
        </pc:sldMkLst>
        <pc:spChg chg="mod">
          <ac:chgData name="Ghielmetti, G, Dr [gghielmetti@sun.ac.za]" userId="75ca0a8f-d75b-460c-b510-c107276c4769" providerId="ADAL" clId="{492E668B-7552-47E9-964C-A1C6E5B17D9B}" dt="2023-07-17T10:40:09.615" v="11"/>
          <ac:spMkLst>
            <pc:docMk/>
            <pc:sldMk cId="822229440" sldId="258"/>
            <ac:spMk id="6" creationId="{DD52FE68-E6CA-4378-5E5B-9EAF6EFEC438}"/>
          </ac:spMkLst>
        </pc:spChg>
      </pc:sldChg>
      <pc:sldChg chg="modSp mod">
        <pc:chgData name="Ghielmetti, G, Dr [gghielmetti@sun.ac.za]" userId="75ca0a8f-d75b-460c-b510-c107276c4769" providerId="ADAL" clId="{492E668B-7552-47E9-964C-A1C6E5B17D9B}" dt="2023-07-17T10:40:13.896" v="12"/>
        <pc:sldMkLst>
          <pc:docMk/>
          <pc:sldMk cId="2334943727" sldId="259"/>
        </pc:sldMkLst>
        <pc:spChg chg="mod">
          <ac:chgData name="Ghielmetti, G, Dr [gghielmetti@sun.ac.za]" userId="75ca0a8f-d75b-460c-b510-c107276c4769" providerId="ADAL" clId="{492E668B-7552-47E9-964C-A1C6E5B17D9B}" dt="2023-07-17T10:40:13.896" v="12"/>
          <ac:spMkLst>
            <pc:docMk/>
            <pc:sldMk cId="2334943727" sldId="259"/>
            <ac:spMk id="6" creationId="{2B023125-0632-6B4A-4E2F-940FEF4E0377}"/>
          </ac:spMkLst>
        </pc:spChg>
      </pc:sldChg>
      <pc:sldChg chg="modSp mod">
        <pc:chgData name="Ghielmetti, G, Dr [gghielmetti@sun.ac.za]" userId="75ca0a8f-d75b-460c-b510-c107276c4769" providerId="ADAL" clId="{492E668B-7552-47E9-964C-A1C6E5B17D9B}" dt="2023-07-17T10:40:28.143" v="20" actId="20577"/>
        <pc:sldMkLst>
          <pc:docMk/>
          <pc:sldMk cId="362020584" sldId="260"/>
        </pc:sldMkLst>
        <pc:spChg chg="mod">
          <ac:chgData name="Ghielmetti, G, Dr [gghielmetti@sun.ac.za]" userId="75ca0a8f-d75b-460c-b510-c107276c4769" providerId="ADAL" clId="{492E668B-7552-47E9-964C-A1C6E5B17D9B}" dt="2023-07-17T10:40:28.143" v="20" actId="20577"/>
          <ac:spMkLst>
            <pc:docMk/>
            <pc:sldMk cId="362020584" sldId="260"/>
            <ac:spMk id="4" creationId="{8CEB3BE3-3237-1F5D-7A6D-01FCC63EEC3C}"/>
          </ac:spMkLst>
        </pc:spChg>
      </pc:sldChg>
      <pc:sldChg chg="modSp mod">
        <pc:chgData name="Ghielmetti, G, Dr [gghielmetti@sun.ac.za]" userId="75ca0a8f-d75b-460c-b510-c107276c4769" providerId="ADAL" clId="{492E668B-7552-47E9-964C-A1C6E5B17D9B}" dt="2023-07-17T10:40:38.472" v="21"/>
        <pc:sldMkLst>
          <pc:docMk/>
          <pc:sldMk cId="1827051940" sldId="261"/>
        </pc:sldMkLst>
        <pc:spChg chg="mod">
          <ac:chgData name="Ghielmetti, G, Dr [gghielmetti@sun.ac.za]" userId="75ca0a8f-d75b-460c-b510-c107276c4769" providerId="ADAL" clId="{492E668B-7552-47E9-964C-A1C6E5B17D9B}" dt="2023-07-17T10:40:38.472" v="21"/>
          <ac:spMkLst>
            <pc:docMk/>
            <pc:sldMk cId="1827051940" sldId="261"/>
            <ac:spMk id="4" creationId="{6E0EAA09-8E1C-6D86-B74A-CF887506CECA}"/>
          </ac:spMkLst>
        </pc:spChg>
      </pc:sldChg>
      <pc:sldChg chg="modSp mod">
        <pc:chgData name="Ghielmetti, G, Dr [gghielmetti@sun.ac.za]" userId="75ca0a8f-d75b-460c-b510-c107276c4769" providerId="ADAL" clId="{492E668B-7552-47E9-964C-A1C6E5B17D9B}" dt="2023-07-17T11:27:22.927" v="184" actId="20577"/>
        <pc:sldMkLst>
          <pc:docMk/>
          <pc:sldMk cId="627583070" sldId="262"/>
        </pc:sldMkLst>
        <pc:spChg chg="mod">
          <ac:chgData name="Ghielmetti, G, Dr [gghielmetti@sun.ac.za]" userId="75ca0a8f-d75b-460c-b510-c107276c4769" providerId="ADAL" clId="{492E668B-7552-47E9-964C-A1C6E5B17D9B}" dt="2023-07-17T11:27:22.927" v="184" actId="20577"/>
          <ac:spMkLst>
            <pc:docMk/>
            <pc:sldMk cId="627583070" sldId="262"/>
            <ac:spMk id="8" creationId="{D4276492-0442-69E1-8F9E-BFDA01C3F27E}"/>
          </ac:spMkLst>
        </pc:spChg>
      </pc:sldChg>
      <pc:sldChg chg="modSp mod">
        <pc:chgData name="Ghielmetti, G, Dr [gghielmetti@sun.ac.za]" userId="75ca0a8f-d75b-460c-b510-c107276c4769" providerId="ADAL" clId="{492E668B-7552-47E9-964C-A1C6E5B17D9B}" dt="2023-07-17T10:40:51.709" v="31" actId="20577"/>
        <pc:sldMkLst>
          <pc:docMk/>
          <pc:sldMk cId="1593709825" sldId="263"/>
        </pc:sldMkLst>
        <pc:spChg chg="mod">
          <ac:chgData name="Ghielmetti, G, Dr [gghielmetti@sun.ac.za]" userId="75ca0a8f-d75b-460c-b510-c107276c4769" providerId="ADAL" clId="{492E668B-7552-47E9-964C-A1C6E5B17D9B}" dt="2023-07-17T10:40:51.709" v="31" actId="20577"/>
          <ac:spMkLst>
            <pc:docMk/>
            <pc:sldMk cId="1593709825" sldId="263"/>
            <ac:spMk id="4" creationId="{FE7E94EA-5918-62A3-9B04-6A52D57E4443}"/>
          </ac:spMkLst>
        </pc:spChg>
      </pc:sldChg>
      <pc:sldChg chg="modSp mod">
        <pc:chgData name="Ghielmetti, G, Dr [gghielmetti@sun.ac.za]" userId="75ca0a8f-d75b-460c-b510-c107276c4769" providerId="ADAL" clId="{492E668B-7552-47E9-964C-A1C6E5B17D9B}" dt="2023-07-17T10:42:13.752" v="57" actId="6549"/>
        <pc:sldMkLst>
          <pc:docMk/>
          <pc:sldMk cId="2117206464" sldId="264"/>
        </pc:sldMkLst>
        <pc:spChg chg="mod">
          <ac:chgData name="Ghielmetti, G, Dr [gghielmetti@sun.ac.za]" userId="75ca0a8f-d75b-460c-b510-c107276c4769" providerId="ADAL" clId="{492E668B-7552-47E9-964C-A1C6E5B17D9B}" dt="2023-07-17T10:42:13.752" v="57" actId="6549"/>
          <ac:spMkLst>
            <pc:docMk/>
            <pc:sldMk cId="2117206464" sldId="264"/>
            <ac:spMk id="4" creationId="{270B78E5-714E-39CD-D0B7-23414597D549}"/>
          </ac:spMkLst>
        </pc:spChg>
      </pc:sldChg>
      <pc:sldChg chg="modSp mod">
        <pc:chgData name="Ghielmetti, G, Dr [gghielmetti@sun.ac.za]" userId="75ca0a8f-d75b-460c-b510-c107276c4769" providerId="ADAL" clId="{492E668B-7552-47E9-964C-A1C6E5B17D9B}" dt="2023-07-17T10:42:32.399" v="68" actId="20577"/>
        <pc:sldMkLst>
          <pc:docMk/>
          <pc:sldMk cId="3790284531" sldId="265"/>
        </pc:sldMkLst>
        <pc:spChg chg="mod">
          <ac:chgData name="Ghielmetti, G, Dr [gghielmetti@sun.ac.za]" userId="75ca0a8f-d75b-460c-b510-c107276c4769" providerId="ADAL" clId="{492E668B-7552-47E9-964C-A1C6E5B17D9B}" dt="2023-07-17T10:42:32.399" v="68" actId="20577"/>
          <ac:spMkLst>
            <pc:docMk/>
            <pc:sldMk cId="3790284531" sldId="265"/>
            <ac:spMk id="4" creationId="{20BB920A-B292-D9E9-B316-A550951C269C}"/>
          </ac:spMkLst>
        </pc:spChg>
      </pc:sldChg>
      <pc:sldChg chg="modSp mod">
        <pc:chgData name="Ghielmetti, G, Dr [gghielmetti@sun.ac.za]" userId="75ca0a8f-d75b-460c-b510-c107276c4769" providerId="ADAL" clId="{492E668B-7552-47E9-964C-A1C6E5B17D9B}" dt="2023-07-17T10:43:07.007" v="71" actId="1076"/>
        <pc:sldMkLst>
          <pc:docMk/>
          <pc:sldMk cId="2102914181" sldId="266"/>
        </pc:sldMkLst>
        <pc:spChg chg="mod">
          <ac:chgData name="Ghielmetti, G, Dr [gghielmetti@sun.ac.za]" userId="75ca0a8f-d75b-460c-b510-c107276c4769" providerId="ADAL" clId="{492E668B-7552-47E9-964C-A1C6E5B17D9B}" dt="2023-07-17T10:43:07.007" v="71" actId="1076"/>
          <ac:spMkLst>
            <pc:docMk/>
            <pc:sldMk cId="2102914181" sldId="266"/>
            <ac:spMk id="6" creationId="{909B945C-9B8F-0EF7-52D8-06347A7FF37C}"/>
          </ac:spMkLst>
        </pc:spChg>
      </pc:sldChg>
      <pc:sldChg chg="modSp mod">
        <pc:chgData name="Ghielmetti, G, Dr [gghielmetti@sun.ac.za]" userId="75ca0a8f-d75b-460c-b510-c107276c4769" providerId="ADAL" clId="{492E668B-7552-47E9-964C-A1C6E5B17D9B}" dt="2023-07-17T10:45:01.743" v="73" actId="20577"/>
        <pc:sldMkLst>
          <pc:docMk/>
          <pc:sldMk cId="4242567760" sldId="267"/>
        </pc:sldMkLst>
        <pc:spChg chg="mod">
          <ac:chgData name="Ghielmetti, G, Dr [gghielmetti@sun.ac.za]" userId="75ca0a8f-d75b-460c-b510-c107276c4769" providerId="ADAL" clId="{492E668B-7552-47E9-964C-A1C6E5B17D9B}" dt="2023-07-17T10:45:01.743" v="73" actId="20577"/>
          <ac:spMkLst>
            <pc:docMk/>
            <pc:sldMk cId="4242567760" sldId="267"/>
            <ac:spMk id="7" creationId="{14CA3CE6-D51D-0768-E1CF-1044B2B32078}"/>
          </ac:spMkLst>
        </pc:spChg>
      </pc:sldChg>
      <pc:sldChg chg="modSp mod">
        <pc:chgData name="Ghielmetti, G, Dr [gghielmetti@sun.ac.za]" userId="75ca0a8f-d75b-460c-b510-c107276c4769" providerId="ADAL" clId="{492E668B-7552-47E9-964C-A1C6E5B17D9B}" dt="2023-07-17T10:45:47.576" v="75" actId="20577"/>
        <pc:sldMkLst>
          <pc:docMk/>
          <pc:sldMk cId="3390738025" sldId="268"/>
        </pc:sldMkLst>
        <pc:spChg chg="mod">
          <ac:chgData name="Ghielmetti, G, Dr [gghielmetti@sun.ac.za]" userId="75ca0a8f-d75b-460c-b510-c107276c4769" providerId="ADAL" clId="{492E668B-7552-47E9-964C-A1C6E5B17D9B}" dt="2023-07-17T10:45:47.576" v="75" actId="20577"/>
          <ac:spMkLst>
            <pc:docMk/>
            <pc:sldMk cId="3390738025" sldId="268"/>
            <ac:spMk id="6" creationId="{A0FC7C5B-D2B2-9CF5-829B-38E4B1EE24FF}"/>
          </ac:spMkLst>
        </pc:spChg>
      </pc:sldChg>
      <pc:sldChg chg="modSp mod">
        <pc:chgData name="Ghielmetti, G, Dr [gghielmetti@sun.ac.za]" userId="75ca0a8f-d75b-460c-b510-c107276c4769" providerId="ADAL" clId="{492E668B-7552-47E9-964C-A1C6E5B17D9B}" dt="2023-07-17T10:46:10.764" v="77" actId="20577"/>
        <pc:sldMkLst>
          <pc:docMk/>
          <pc:sldMk cId="3663258795" sldId="269"/>
        </pc:sldMkLst>
        <pc:spChg chg="mod">
          <ac:chgData name="Ghielmetti, G, Dr [gghielmetti@sun.ac.za]" userId="75ca0a8f-d75b-460c-b510-c107276c4769" providerId="ADAL" clId="{492E668B-7552-47E9-964C-A1C6E5B17D9B}" dt="2023-07-17T10:46:10.764" v="77" actId="20577"/>
          <ac:spMkLst>
            <pc:docMk/>
            <pc:sldMk cId="3663258795" sldId="269"/>
            <ac:spMk id="6" creationId="{969786F5-D40B-4492-FADA-7CB47F5B4688}"/>
          </ac:spMkLst>
        </pc:spChg>
      </pc:sldChg>
      <pc:sldChg chg="modSp mod">
        <pc:chgData name="Ghielmetti, G, Dr [gghielmetti@sun.ac.za]" userId="75ca0a8f-d75b-460c-b510-c107276c4769" providerId="ADAL" clId="{492E668B-7552-47E9-964C-A1C6E5B17D9B}" dt="2023-07-17T10:52:19.150" v="79" actId="20577"/>
        <pc:sldMkLst>
          <pc:docMk/>
          <pc:sldMk cId="3556407604" sldId="270"/>
        </pc:sldMkLst>
        <pc:spChg chg="mod">
          <ac:chgData name="Ghielmetti, G, Dr [gghielmetti@sun.ac.za]" userId="75ca0a8f-d75b-460c-b510-c107276c4769" providerId="ADAL" clId="{492E668B-7552-47E9-964C-A1C6E5B17D9B}" dt="2023-07-17T10:52:19.150" v="79" actId="20577"/>
          <ac:spMkLst>
            <pc:docMk/>
            <pc:sldMk cId="3556407604" sldId="270"/>
            <ac:spMk id="6" creationId="{E09DE637-38C3-5B0C-5B44-EF0B3766EDEE}"/>
          </ac:spMkLst>
        </pc:spChg>
      </pc:sldChg>
      <pc:sldChg chg="modSp mod">
        <pc:chgData name="Ghielmetti, G, Dr [gghielmetti@sun.ac.za]" userId="75ca0a8f-d75b-460c-b510-c107276c4769" providerId="ADAL" clId="{492E668B-7552-47E9-964C-A1C6E5B17D9B}" dt="2023-07-17T11:10:53.684" v="85" actId="20577"/>
        <pc:sldMkLst>
          <pc:docMk/>
          <pc:sldMk cId="1486577638" sldId="271"/>
        </pc:sldMkLst>
        <pc:spChg chg="mod">
          <ac:chgData name="Ghielmetti, G, Dr [gghielmetti@sun.ac.za]" userId="75ca0a8f-d75b-460c-b510-c107276c4769" providerId="ADAL" clId="{492E668B-7552-47E9-964C-A1C6E5B17D9B}" dt="2023-07-17T11:10:53.684" v="85" actId="20577"/>
          <ac:spMkLst>
            <pc:docMk/>
            <pc:sldMk cId="1486577638" sldId="271"/>
            <ac:spMk id="4" creationId="{6E3030DB-CF1C-BB0F-CEBD-E5CA5D3CACB2}"/>
          </ac:spMkLst>
        </pc:spChg>
      </pc:sldChg>
      <pc:sldChg chg="modSp mod">
        <pc:chgData name="Ghielmetti, G, Dr [gghielmetti@sun.ac.za]" userId="75ca0a8f-d75b-460c-b510-c107276c4769" providerId="ADAL" clId="{492E668B-7552-47E9-964C-A1C6E5B17D9B}" dt="2023-07-17T11:21:43.729" v="174" actId="20577"/>
        <pc:sldMkLst>
          <pc:docMk/>
          <pc:sldMk cId="3102730352" sldId="273"/>
        </pc:sldMkLst>
        <pc:spChg chg="mod">
          <ac:chgData name="Ghielmetti, G, Dr [gghielmetti@sun.ac.za]" userId="75ca0a8f-d75b-460c-b510-c107276c4769" providerId="ADAL" clId="{492E668B-7552-47E9-964C-A1C6E5B17D9B}" dt="2023-07-17T11:21:43.729" v="174" actId="20577"/>
          <ac:spMkLst>
            <pc:docMk/>
            <pc:sldMk cId="3102730352" sldId="273"/>
            <ac:spMk id="6" creationId="{089E6FF8-F17A-2B84-1492-6E78EFF76FD3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08BD55-2A81-B681-A481-66959DA7948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EBD9419-0926-079F-9B45-D7860DA61AC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7B7596-8BEF-0260-76A5-7997E656CA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F66F7-DF79-4027-BCC2-6E6D7F0560EE}" type="datetimeFigureOut">
              <a:rPr lang="en-ZA" smtClean="0"/>
              <a:t>2023/08/03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57B682-3AF7-13FE-5FF0-372633CCE8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BE888A-613D-899D-9CDC-6703834DBE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EAD94-A646-48AE-8981-DDA07FA60515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4643051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752E14-BD7B-FB86-FA21-527C097332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12872B6-B5FD-3116-1D37-7A9D5808E8D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BD1DAB-7E05-FF66-9371-06C1493F2F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F66F7-DF79-4027-BCC2-6E6D7F0560EE}" type="datetimeFigureOut">
              <a:rPr lang="en-ZA" smtClean="0"/>
              <a:t>2023/08/03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57153C-F351-0E27-60BB-FDED9723BC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8B3BFC-DE8F-BD17-ED54-0CCF6CD156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EAD94-A646-48AE-8981-DDA07FA60515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1625991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DC62E55-9C44-94F9-1577-CE0E97DB304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3E8E498-A80A-08D1-F881-D547D84CAC5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7E9587-C765-B45D-18BB-4569FE2C29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F66F7-DF79-4027-BCC2-6E6D7F0560EE}" type="datetimeFigureOut">
              <a:rPr lang="en-ZA" smtClean="0"/>
              <a:t>2023/08/03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E26D1D-E754-8364-ABA2-B725F6DC66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985C4C-A052-7714-A89A-A7C0B10F35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EAD94-A646-48AE-8981-DDA07FA60515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3812268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43D8A6-9C64-2B4C-AD93-F530E09817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CD1847-F8C0-5D09-1906-7D165ABC6DC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4F90FC-7397-8BCC-EF98-731FAA903F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F66F7-DF79-4027-BCC2-6E6D7F0560EE}" type="datetimeFigureOut">
              <a:rPr lang="en-ZA" smtClean="0"/>
              <a:t>2023/08/03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101C94-09C1-F9F1-C59A-779AD77526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6FB60E-A1F9-C055-BDAA-F88D987394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EAD94-A646-48AE-8981-DDA07FA60515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8014005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87570B-B091-2891-DB34-AA44F17251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9EC03C0-7EE9-47D7-8D17-A2E8D1C140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33CA68-9EF9-5411-6178-398E34D891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F66F7-DF79-4027-BCC2-6E6D7F0560EE}" type="datetimeFigureOut">
              <a:rPr lang="en-ZA" smtClean="0"/>
              <a:t>2023/08/03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2DA65F-E376-E222-F629-0300936854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11FA36-F902-8FB3-6753-15B6E725E9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EAD94-A646-48AE-8981-DDA07FA60515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9374745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B63212-C83B-58B9-CA9C-598B066B5C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B6B08F-7D45-0DBE-162A-6F1B78ACD6E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F205319-1843-7913-7470-DE3D19DCD7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668124F-E1D8-5F0E-BF81-B91831A578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F66F7-DF79-4027-BCC2-6E6D7F0560EE}" type="datetimeFigureOut">
              <a:rPr lang="en-ZA" smtClean="0"/>
              <a:t>2023/08/03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896E213-ACE3-3ED3-BCEE-BC795889C0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7A0CF22-4BFD-A182-5E8D-2CD26E7ED9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EAD94-A646-48AE-8981-DDA07FA60515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0798592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E376E3-2326-A344-7EE6-D33B94CB21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179B8B0-6987-8E2D-FF63-C6D3BE12F8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53A8D5F-FC44-575F-EE56-D54191AA493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4091DBF-8DC3-4446-A62C-BC733C7BCBF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81CBA01-DD04-0ED4-A57C-66C21912CE9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F070A10-35C8-AD80-22C1-A6E701D50D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F66F7-DF79-4027-BCC2-6E6D7F0560EE}" type="datetimeFigureOut">
              <a:rPr lang="en-ZA" smtClean="0"/>
              <a:t>2023/08/03</a:t>
            </a:fld>
            <a:endParaRPr lang="en-Z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1B895B1-4DF4-EE58-D4C5-5ADBA34443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4326494-9F38-092F-CADB-CC9FAD5155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EAD94-A646-48AE-8981-DDA07FA60515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2804981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D52DB7-339B-F0F2-BB3F-F5D10FE65F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7866F88-BF80-AC91-488D-F02E7989F3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F66F7-DF79-4027-BCC2-6E6D7F0560EE}" type="datetimeFigureOut">
              <a:rPr lang="en-ZA" smtClean="0"/>
              <a:t>2023/08/03</a:t>
            </a:fld>
            <a:endParaRPr lang="en-Z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263DB33-A66B-5F75-41F7-9BBD60594C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66FE0F2-EB72-38DC-348E-072C980329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EAD94-A646-48AE-8981-DDA07FA60515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1809280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2254259-FFF7-38B8-096D-DC3ABCDAAB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F66F7-DF79-4027-BCC2-6E6D7F0560EE}" type="datetimeFigureOut">
              <a:rPr lang="en-ZA" smtClean="0"/>
              <a:t>2023/08/03</a:t>
            </a:fld>
            <a:endParaRPr lang="en-Z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0CCE036-D811-6A4C-EDB2-42BAC610B6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A88F259-D683-424B-8743-4156887141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EAD94-A646-48AE-8981-DDA07FA60515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1347942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B9E141-983C-4BAC-E0F5-6FB71CC4C9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8C3442-B940-F6D1-1F8B-D6FD6277E60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D30C713-5C08-7FB5-1A59-7DF99A7A959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871E37-63EA-1364-EEB0-DE33AA865D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F66F7-DF79-4027-BCC2-6E6D7F0560EE}" type="datetimeFigureOut">
              <a:rPr lang="en-ZA" smtClean="0"/>
              <a:t>2023/08/03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AA38363-B509-F150-0E5F-0E4A270869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50C22B0-21B4-795E-680D-F8449BB22E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EAD94-A646-48AE-8981-DDA07FA60515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4167154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1BAAD2-A84A-D2AF-13A7-D5A6296716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A60DFEB-0938-1A42-281C-195C31E6859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5AD29E0-4DA1-9C56-76DB-FBE3CEC1000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10C51E2-A04B-5527-896F-2D876C178D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F66F7-DF79-4027-BCC2-6E6D7F0560EE}" type="datetimeFigureOut">
              <a:rPr lang="en-ZA" smtClean="0"/>
              <a:t>2023/08/03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3CBD79C-7EFD-1543-D17C-14E82F3313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B561EB7-4E5E-7E93-8FCE-AB1CCF2338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EAD94-A646-48AE-8981-DDA07FA60515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6785240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8B6EAEE-F8EB-AE7E-9EC9-AD8ECCFF59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7866134-2068-5C4F-D60D-BEC588E23F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76B453-3EDD-0F77-1029-2BF34233EA1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1F66F7-DF79-4027-BCC2-6E6D7F0560EE}" type="datetimeFigureOut">
              <a:rPr lang="en-ZA" smtClean="0"/>
              <a:t>2023/08/03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E648A2-803D-DDB9-3CC3-766E9B51F32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C76BEF-E872-71FB-E716-073987BFFF5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0EAD94-A646-48AE-8981-DDA07FA60515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446949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F2E5B383-15C9-5F2B-E11F-8618B400D08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90582" y="361383"/>
            <a:ext cx="9065741" cy="4947952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6FA70752-86C8-4103-232E-267BB3B079F1}"/>
              </a:ext>
            </a:extLst>
          </p:cNvPr>
          <p:cNvSpPr txBox="1"/>
          <p:nvPr/>
        </p:nvSpPr>
        <p:spPr>
          <a:xfrm>
            <a:off x="951470" y="5708822"/>
            <a:ext cx="39665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NB18191_culture</a:t>
            </a:r>
            <a:r>
              <a:rPr lang="en-ZA" dirty="0"/>
              <a:t> - 1122198</a:t>
            </a:r>
          </a:p>
        </p:txBody>
      </p:sp>
    </p:spTree>
    <p:extLst>
      <p:ext uri="{BB962C8B-B14F-4D97-AF65-F5344CB8AC3E}">
        <p14:creationId xmlns:p14="http://schemas.microsoft.com/office/powerpoint/2010/main" val="303165282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0BB920A-B292-D9E9-B316-A550951C269C}"/>
              </a:ext>
            </a:extLst>
          </p:cNvPr>
          <p:cNvSpPr txBox="1"/>
          <p:nvPr/>
        </p:nvSpPr>
        <p:spPr>
          <a:xfrm>
            <a:off x="1538110" y="5891169"/>
            <a:ext cx="68289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NB18211_culture </a:t>
            </a:r>
            <a:r>
              <a:rPr lang="en-ZA" dirty="0"/>
              <a:t>– 3082915 – same as previous slide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3750D831-5FD2-8DE9-FDED-FEA3057760A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09010" y="178050"/>
            <a:ext cx="9256295" cy="50519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9028453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0C49DC21-2E6E-9A02-FBAA-A3FD59B38FE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24000" y="101891"/>
            <a:ext cx="8689903" cy="474282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09B945C-9B8F-0EF7-52D8-06347A7FF37C}"/>
              </a:ext>
            </a:extLst>
          </p:cNvPr>
          <p:cNvSpPr txBox="1"/>
          <p:nvPr/>
        </p:nvSpPr>
        <p:spPr>
          <a:xfrm>
            <a:off x="1524000" y="5706611"/>
            <a:ext cx="68289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NB18211_culture </a:t>
            </a:r>
            <a:r>
              <a:rPr lang="en-ZA" dirty="0"/>
              <a:t>– 1122198 – same explanation</a:t>
            </a:r>
          </a:p>
        </p:txBody>
      </p:sp>
    </p:spTree>
    <p:extLst>
      <p:ext uri="{BB962C8B-B14F-4D97-AF65-F5344CB8AC3E}">
        <p14:creationId xmlns:p14="http://schemas.microsoft.com/office/powerpoint/2010/main" val="210291418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894603A-E601-C9FE-B4B5-B355F1F38F10}"/>
              </a:ext>
            </a:extLst>
          </p:cNvPr>
          <p:cNvSpPr txBox="1"/>
          <p:nvPr/>
        </p:nvSpPr>
        <p:spPr>
          <a:xfrm>
            <a:off x="1250462" y="148492"/>
            <a:ext cx="969107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dirty="0"/>
              <a:t>The next few slides are the true variants identified from ONT and not in Illumina. Well, TECHNICAL true variants, but these variants are all a few </a:t>
            </a:r>
            <a:r>
              <a:rPr lang="en-ZA" dirty="0" err="1"/>
              <a:t>basepairs</a:t>
            </a:r>
            <a:r>
              <a:rPr lang="en-ZA" dirty="0"/>
              <a:t> from another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36857F33-B7B9-1AB0-BB0B-CE507C88F35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50462" y="933668"/>
            <a:ext cx="9144000" cy="499066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14CA3CE6-D51D-0768-E1CF-1044B2B32078}"/>
              </a:ext>
            </a:extLst>
          </p:cNvPr>
          <p:cNvSpPr txBox="1"/>
          <p:nvPr/>
        </p:nvSpPr>
        <p:spPr>
          <a:xfrm>
            <a:off x="1512943" y="6310618"/>
            <a:ext cx="68289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NB18211_culture </a:t>
            </a:r>
            <a:r>
              <a:rPr lang="en-ZA" dirty="0"/>
              <a:t>– 2158436</a:t>
            </a:r>
          </a:p>
        </p:txBody>
      </p:sp>
    </p:spTree>
    <p:extLst>
      <p:ext uri="{BB962C8B-B14F-4D97-AF65-F5344CB8AC3E}">
        <p14:creationId xmlns:p14="http://schemas.microsoft.com/office/powerpoint/2010/main" val="424256776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46A06CE2-DA8C-44A6-C2BA-0366D5D5145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74691" y="166059"/>
            <a:ext cx="9042617" cy="493533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0FC7C5B-D2B2-9CF5-829B-38E4B1EE24FF}"/>
              </a:ext>
            </a:extLst>
          </p:cNvPr>
          <p:cNvSpPr txBox="1"/>
          <p:nvPr/>
        </p:nvSpPr>
        <p:spPr>
          <a:xfrm>
            <a:off x="1512943" y="6310618"/>
            <a:ext cx="68289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NB18211_culture </a:t>
            </a:r>
            <a:r>
              <a:rPr lang="en-ZA" dirty="0"/>
              <a:t>– 2158439</a:t>
            </a:r>
          </a:p>
        </p:txBody>
      </p:sp>
    </p:spTree>
    <p:extLst>
      <p:ext uri="{BB962C8B-B14F-4D97-AF65-F5344CB8AC3E}">
        <p14:creationId xmlns:p14="http://schemas.microsoft.com/office/powerpoint/2010/main" val="339073802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F6A1C195-EDCD-F876-983E-8FBA21CFF4E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4694" y="178050"/>
            <a:ext cx="8484155" cy="463053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69786F5-D40B-4492-FADA-7CB47F5B4688}"/>
              </a:ext>
            </a:extLst>
          </p:cNvPr>
          <p:cNvSpPr txBox="1"/>
          <p:nvPr/>
        </p:nvSpPr>
        <p:spPr>
          <a:xfrm>
            <a:off x="389995" y="5620807"/>
            <a:ext cx="68289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NB18211_culture </a:t>
            </a:r>
            <a:r>
              <a:rPr lang="en-ZA" dirty="0"/>
              <a:t>– 2158436, 2158439, 2158443, 2158445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F821415-1CFE-FEB9-E7E7-E1CDCF2ABAA5}"/>
              </a:ext>
            </a:extLst>
          </p:cNvPr>
          <p:cNvSpPr txBox="1"/>
          <p:nvPr/>
        </p:nvSpPr>
        <p:spPr>
          <a:xfrm>
            <a:off x="1195754" y="5134708"/>
            <a:ext cx="42515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dirty="0"/>
              <a:t>Three very close variants, position wise</a:t>
            </a:r>
          </a:p>
        </p:txBody>
      </p:sp>
    </p:spTree>
    <p:extLst>
      <p:ext uri="{BB962C8B-B14F-4D97-AF65-F5344CB8AC3E}">
        <p14:creationId xmlns:p14="http://schemas.microsoft.com/office/powerpoint/2010/main" val="366325879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8779823-A954-4EDD-9172-53A87BDDDBE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06391" y="101891"/>
            <a:ext cx="9454114" cy="515992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09DE637-38C3-5B0C-5B44-EF0B3766EDEE}"/>
              </a:ext>
            </a:extLst>
          </p:cNvPr>
          <p:cNvSpPr txBox="1"/>
          <p:nvPr/>
        </p:nvSpPr>
        <p:spPr>
          <a:xfrm>
            <a:off x="1406391" y="6005818"/>
            <a:ext cx="68289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NB18211_culture </a:t>
            </a:r>
            <a:r>
              <a:rPr lang="en-ZA" dirty="0"/>
              <a:t>– 2284747, 2284749, 228475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7D0A5E2-6326-1618-DBD3-9221C5CCABED}"/>
              </a:ext>
            </a:extLst>
          </p:cNvPr>
          <p:cNvSpPr txBox="1"/>
          <p:nvPr/>
        </p:nvSpPr>
        <p:spPr>
          <a:xfrm>
            <a:off x="2212150" y="5519719"/>
            <a:ext cx="42515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dirty="0"/>
              <a:t>Three very close variants, position wise</a:t>
            </a:r>
          </a:p>
        </p:txBody>
      </p:sp>
    </p:spTree>
    <p:extLst>
      <p:ext uri="{BB962C8B-B14F-4D97-AF65-F5344CB8AC3E}">
        <p14:creationId xmlns:p14="http://schemas.microsoft.com/office/powerpoint/2010/main" val="3556407604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E3030DB-CF1C-BB0F-CEBD-E5CA5D3CACB2}"/>
              </a:ext>
            </a:extLst>
          </p:cNvPr>
          <p:cNvSpPr txBox="1"/>
          <p:nvPr/>
        </p:nvSpPr>
        <p:spPr>
          <a:xfrm>
            <a:off x="1406391" y="6005818"/>
            <a:ext cx="68289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NB18211_culture </a:t>
            </a:r>
            <a:r>
              <a:rPr lang="en-ZA" dirty="0"/>
              <a:t>– 4194117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9865E427-927A-8D22-C013-1BCBF7E402E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71074" y="101891"/>
            <a:ext cx="9718646" cy="53042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86577638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00217693-ABA3-51F6-3F5E-5770B92FBEF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51284" y="101891"/>
            <a:ext cx="9432758" cy="514826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683284A-7AE9-63EF-ECA5-F8F0F5A717BB}"/>
              </a:ext>
            </a:extLst>
          </p:cNvPr>
          <p:cNvSpPr txBox="1"/>
          <p:nvPr/>
        </p:nvSpPr>
        <p:spPr>
          <a:xfrm>
            <a:off x="1251284" y="5568156"/>
            <a:ext cx="936982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dirty="0"/>
              <a:t>NB18246 – 4194117</a:t>
            </a:r>
          </a:p>
          <a:p>
            <a:r>
              <a:rPr lang="en-ZA" dirty="0"/>
              <a:t>Position called confidently because the coverage is good, and the variant is found here in more than 90% of the reads</a:t>
            </a:r>
          </a:p>
        </p:txBody>
      </p:sp>
    </p:spTree>
    <p:extLst>
      <p:ext uri="{BB962C8B-B14F-4D97-AF65-F5344CB8AC3E}">
        <p14:creationId xmlns:p14="http://schemas.microsoft.com/office/powerpoint/2010/main" val="892144494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12FDB20-6569-FB6A-273C-D1E5DF6C983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58461" y="117522"/>
            <a:ext cx="9308123" cy="508024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89E6FF8-F17A-2B84-1492-6E78EFF76FD3}"/>
              </a:ext>
            </a:extLst>
          </p:cNvPr>
          <p:cNvSpPr txBox="1"/>
          <p:nvPr/>
        </p:nvSpPr>
        <p:spPr>
          <a:xfrm>
            <a:off x="1251284" y="5568156"/>
            <a:ext cx="936982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dirty="0"/>
              <a:t>NB18193 – 4194117</a:t>
            </a:r>
          </a:p>
          <a:p>
            <a:r>
              <a:rPr lang="en-ZA" dirty="0"/>
              <a:t>Possibility here of an underlying population that has a ‘’WT” position. The variant is found in slightly less than 90% of the reads and can therefore not be called as ‘’fixed”. However, for the ONT sequences the WT was only seen once. We interpret this call as </a:t>
            </a:r>
            <a:r>
              <a:rPr lang="en-ZA" dirty="0" err="1"/>
              <a:t>mismapping</a:t>
            </a:r>
            <a:r>
              <a:rPr lang="en-ZA" dirty="0"/>
              <a:t> for the Illumina data.</a:t>
            </a:r>
          </a:p>
        </p:txBody>
      </p:sp>
    </p:spTree>
    <p:extLst>
      <p:ext uri="{BB962C8B-B14F-4D97-AF65-F5344CB8AC3E}">
        <p14:creationId xmlns:p14="http://schemas.microsoft.com/office/powerpoint/2010/main" val="31027303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5F52B750-E313-1EB1-A84D-1BAA381BDAA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52367" y="126604"/>
            <a:ext cx="8872151" cy="484229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5D8137E-B376-7F42-E8D7-5257D9610BE8}"/>
              </a:ext>
            </a:extLst>
          </p:cNvPr>
          <p:cNvSpPr txBox="1"/>
          <p:nvPr/>
        </p:nvSpPr>
        <p:spPr>
          <a:xfrm>
            <a:off x="1865870" y="5412260"/>
            <a:ext cx="39665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NB18191_culture</a:t>
            </a:r>
            <a:r>
              <a:rPr lang="en-ZA" dirty="0"/>
              <a:t> - 1122198</a:t>
            </a:r>
          </a:p>
        </p:txBody>
      </p:sp>
    </p:spTree>
    <p:extLst>
      <p:ext uri="{BB962C8B-B14F-4D97-AF65-F5344CB8AC3E}">
        <p14:creationId xmlns:p14="http://schemas.microsoft.com/office/powerpoint/2010/main" val="22011533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3F378C03-C62C-3D3D-BEE8-4CDAFB60C3B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91916" y="117933"/>
            <a:ext cx="9817768" cy="535839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D52FE68-E6CA-4378-5E5B-9EAF6EFEC438}"/>
              </a:ext>
            </a:extLst>
          </p:cNvPr>
          <p:cNvSpPr txBox="1"/>
          <p:nvPr/>
        </p:nvSpPr>
        <p:spPr>
          <a:xfrm>
            <a:off x="1705449" y="5877481"/>
            <a:ext cx="39665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NB18191_culture</a:t>
            </a:r>
            <a:r>
              <a:rPr lang="en-ZA" dirty="0"/>
              <a:t> - 3082915</a:t>
            </a:r>
          </a:p>
        </p:txBody>
      </p:sp>
    </p:spTree>
    <p:extLst>
      <p:ext uri="{BB962C8B-B14F-4D97-AF65-F5344CB8AC3E}">
        <p14:creationId xmlns:p14="http://schemas.microsoft.com/office/powerpoint/2010/main" val="8222294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D893F5C2-40BB-998D-0123-13D683DC7CA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75872" y="133974"/>
            <a:ext cx="9914021" cy="541093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B023125-0632-6B4A-4E2F-940FEF4E0377}"/>
              </a:ext>
            </a:extLst>
          </p:cNvPr>
          <p:cNvSpPr txBox="1"/>
          <p:nvPr/>
        </p:nvSpPr>
        <p:spPr>
          <a:xfrm>
            <a:off x="1705449" y="5877481"/>
            <a:ext cx="39665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NB18191_culture</a:t>
            </a:r>
            <a:r>
              <a:rPr lang="en-ZA" dirty="0"/>
              <a:t> - 3082915</a:t>
            </a:r>
          </a:p>
        </p:txBody>
      </p:sp>
    </p:spTree>
    <p:extLst>
      <p:ext uri="{BB962C8B-B14F-4D97-AF65-F5344CB8AC3E}">
        <p14:creationId xmlns:p14="http://schemas.microsoft.com/office/powerpoint/2010/main" val="233494372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CEB3BE3-3237-1F5D-7A6D-01FCC63EEC3C}"/>
              </a:ext>
            </a:extLst>
          </p:cNvPr>
          <p:cNvSpPr txBox="1"/>
          <p:nvPr/>
        </p:nvSpPr>
        <p:spPr>
          <a:xfrm>
            <a:off x="1705449" y="5877481"/>
            <a:ext cx="39665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NB18246_direct</a:t>
            </a:r>
            <a:r>
              <a:rPr lang="de-CH" dirty="0"/>
              <a:t> </a:t>
            </a:r>
            <a:r>
              <a:rPr lang="en-ZA" dirty="0"/>
              <a:t>- 1122198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C9A09A1D-A6C8-AA12-E391-B8E2EC1A21F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73179" y="262312"/>
            <a:ext cx="8871284" cy="48418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202058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E0EAA09-8E1C-6D86-B74A-CF887506CECA}"/>
              </a:ext>
            </a:extLst>
          </p:cNvPr>
          <p:cNvSpPr txBox="1"/>
          <p:nvPr/>
        </p:nvSpPr>
        <p:spPr>
          <a:xfrm>
            <a:off x="1561070" y="6310618"/>
            <a:ext cx="39665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NB18246_direct</a:t>
            </a:r>
            <a:r>
              <a:rPr lang="de-CH" dirty="0"/>
              <a:t> </a:t>
            </a:r>
            <a:r>
              <a:rPr lang="en-ZA" dirty="0"/>
              <a:t>- 1122198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261B73F5-7001-522C-4EB8-91CA7ABB3A0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4610" y="178050"/>
            <a:ext cx="10482856" cy="57213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2705194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C8EB28E2-01AF-0DB5-1CE7-E90B4AB3239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56430" y="101891"/>
            <a:ext cx="9248366" cy="504762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D4276492-0442-69E1-8F9E-BFDA01C3F27E}"/>
              </a:ext>
            </a:extLst>
          </p:cNvPr>
          <p:cNvSpPr txBox="1"/>
          <p:nvPr/>
        </p:nvSpPr>
        <p:spPr>
          <a:xfrm>
            <a:off x="1561070" y="6310618"/>
            <a:ext cx="39665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dirty="0"/>
              <a:t>NB18246_direct - 3082915</a:t>
            </a:r>
          </a:p>
        </p:txBody>
      </p:sp>
    </p:spTree>
    <p:extLst>
      <p:ext uri="{BB962C8B-B14F-4D97-AF65-F5344CB8AC3E}">
        <p14:creationId xmlns:p14="http://schemas.microsoft.com/office/powerpoint/2010/main" val="62758307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E7E94EA-5918-62A3-9B04-6A52D57E4443}"/>
              </a:ext>
            </a:extLst>
          </p:cNvPr>
          <p:cNvSpPr txBox="1"/>
          <p:nvPr/>
        </p:nvSpPr>
        <p:spPr>
          <a:xfrm>
            <a:off x="1625238" y="5756620"/>
            <a:ext cx="960423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NB18193_culture </a:t>
            </a:r>
            <a:r>
              <a:rPr lang="en-ZA" dirty="0"/>
              <a:t>– 1122198 </a:t>
            </a:r>
          </a:p>
          <a:p>
            <a:r>
              <a:rPr lang="en-ZA" dirty="0"/>
              <a:t>Variant called as ‘T’ because the only bases who mapped, 4, were T’s. But the majority of positions are deleted.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EA903C95-DBAA-EB46-B2D1-D884D220FD1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25238" y="178050"/>
            <a:ext cx="9753600" cy="53233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9370982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70B78E5-714E-39CD-D0B7-23414597D549}"/>
              </a:ext>
            </a:extLst>
          </p:cNvPr>
          <p:cNvSpPr txBox="1"/>
          <p:nvPr/>
        </p:nvSpPr>
        <p:spPr>
          <a:xfrm>
            <a:off x="1566515" y="5488172"/>
            <a:ext cx="960423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NB18193_culture </a:t>
            </a:r>
            <a:r>
              <a:rPr lang="en-ZA" dirty="0"/>
              <a:t>– 3082915</a:t>
            </a:r>
          </a:p>
          <a:p>
            <a:r>
              <a:rPr lang="en-ZA" dirty="0"/>
              <a:t>Only one bp mapped (C). Therefore the pipeline recognizes this is 100% fixed position. But it’s is clearly a deletion.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C1662CE9-476E-5924-0177-66E08B84D83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33600" y="150017"/>
            <a:ext cx="9095874" cy="49643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172064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5</Words>
  <Application>Microsoft Office PowerPoint</Application>
  <PresentationFormat>Widescreen</PresentationFormat>
  <Paragraphs>25</Paragraphs>
  <Slides>1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8</vt:i4>
      </vt:variant>
    </vt:vector>
  </HeadingPairs>
  <TitlesOfParts>
    <vt:vector size="2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Stellenbosch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oubser, Hanno [jloubser@sun.ac.za]</dc:creator>
  <cp:lastModifiedBy>Ghielmetti, G, Dr [gghielmetti@sun.ac.za]</cp:lastModifiedBy>
  <cp:revision>2</cp:revision>
  <dcterms:created xsi:type="dcterms:W3CDTF">2023-07-14T13:21:36Z</dcterms:created>
  <dcterms:modified xsi:type="dcterms:W3CDTF">2023-08-04T01:13:00Z</dcterms:modified>
</cp:coreProperties>
</file>